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2" d="100"/>
          <a:sy n="102" d="100"/>
        </p:scale>
        <p:origin x="738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7E0C80-9FEC-73E4-07A5-6A8CA33D05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484BFCE-BBA3-B78E-16A7-78959A593C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58CE1B-20D8-62D1-7FDD-ACF6A72A6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12BED-17C9-DEBB-2557-F348B8CEF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2D58A5-AD63-2E66-2F22-5501A8FE6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874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0293C6-AE33-7618-1076-70300FA87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0A4A6D2-C66E-09FD-9EE7-AF99D58689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4672FD-E2FD-8D5B-D7B3-6C99CA04A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CB1120-4158-2E9B-A680-A1BE1155B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3CBFAB-06DB-A3DB-B19A-C4AEB9712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492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24CEA6D-F6B4-F115-6241-5D3A38545B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5A70BF-D370-483E-5DA3-B6E5523B3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698928-CACA-74CB-E51A-2EE45148C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619391-444D-99CD-09A9-3CF3C670C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4D4BA5-CAF3-65A3-2C01-7112FE1C6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793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76D1E7-80B2-EF58-54FC-45D401C33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80B7A6-A133-6D41-A9AB-039AB10613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E6D9A6-3748-4B49-C37F-EBCF8BAF4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6A3A55-DE3F-425D-A42D-D6EE5AABD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B31359-BC76-F825-D164-40DD3AA99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2085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844023-86C5-2568-15CE-BF2456C2D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D5110F4-92A7-C8DD-FD59-BF8CDBA14C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3C88BA-5A60-9737-6F10-48B704AA7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5B8CC8-FAF2-8D6A-D9E4-0F0901305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F3F21D-9347-89F6-106F-6593C2EFA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1156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5CD69E-0A4A-607E-7EF3-3CE97D1E82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988122F-3F73-D8A5-55FA-0119A925EE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B96ADC9-D40E-237C-34B2-4C7F20D75F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0B9D92-25B0-2D71-97E0-C073272AC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AA4D7D-8572-378E-0207-60F2EBDF1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D429AE-1CEA-799C-CF29-78F6F26B4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89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D483BB-1C37-10E6-EB7A-6DD0133B1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54D04DD-0340-81F3-B703-6AA437BC12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E05321A-E9E2-ADFB-2E12-F600F832C3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A31C81-70EB-B186-133E-B3CE4B5E2F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C03AC16-381C-06BD-8DA5-2E8A5A15A1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B59494F-25F4-5B06-2194-7AD35EA9A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324B743-3BA8-9C7B-2844-69F2028DE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B3BF62C-79E6-F456-EC66-108440197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8003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DB74D5-D795-5A94-00E4-C7B065CD2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0DE1C2E-CCEA-0563-7B2F-B4854AB9B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ACB3B25-C3BD-E758-E0EB-EB49F2FD9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F69CF78-B08B-3DB3-0105-1EA43E267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602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E79F6FF-0247-190E-ECA6-F50F4898F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504BE4E-177A-049C-B510-8F3312831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6B5D0AF-CD7C-E662-692C-B91C885A2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3858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A11C47-6D3F-B222-8F67-81E76BF87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207FD8-BFCD-DB32-14B9-9DB5CC9A8E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15A9B1-DCDF-7559-BB6A-01D0B8178E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9A9B58-2171-146A-BBFC-83F2653FB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166A6D-5836-22A3-9173-9E7795EB9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C7F86A-B977-EDBA-7520-412294AC8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1622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EF64AF-9C8C-481D-B865-26DBDBF43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2AD0E2A-08A8-AE00-12F4-B436F68B70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C45843E-73A9-64E1-A9FF-F7731E0DE5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18EB93-A095-E57F-09EA-9F0EBCF0E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2501A1-4698-D206-1146-E553F9AEE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608E89-857C-6DAA-D293-39B1B161C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682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D9FB389-E224-C687-B3D0-4D7A9CB443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8A935C4-197C-2479-36F4-24CCF27580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3FE472-BAD2-1006-FB61-0417DECD51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D2CD4-CBE2-4906-9606-4508485509A9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DDD09F-8CBD-5EB5-CCC7-7B0BA4B626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F343A8-8B97-23D2-D7F4-9C82A64C0A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85A3F-7FEC-437C-B6F5-DBE5064FD4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931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B80981DE-038E-4FBB-72C8-FA9A399B50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565985" y="5831991"/>
            <a:ext cx="7985215" cy="501936"/>
          </a:xfrm>
        </p:spPr>
        <p:txBody>
          <a:bodyPr>
            <a:normAutofit/>
          </a:bodyPr>
          <a:lstStyle/>
          <a:p>
            <a:pPr algn="just"/>
            <a:r>
              <a:rPr lang="en-US" altLang="zh-CN" sz="14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7. Gene expression and metabolite abundance correlation network diagram. </a:t>
            </a:r>
            <a:r>
              <a:rPr lang="en-US" altLang="zh-CN" sz="14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yellow lines show a positive correlation and the blue lines show a negative correlation.</a:t>
            </a:r>
          </a:p>
          <a:p>
            <a:pPr algn="just"/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57E3180-4590-768A-6ABE-29AAA8924F7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64" t="12223" r="6579" b="10899"/>
          <a:stretch/>
        </p:blipFill>
        <p:spPr>
          <a:xfrm>
            <a:off x="3859966" y="524073"/>
            <a:ext cx="6082733" cy="49848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3670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靖欣 霍</dc:creator>
  <cp:lastModifiedBy>靖欣 霍</cp:lastModifiedBy>
  <cp:revision>1</cp:revision>
  <dcterms:created xsi:type="dcterms:W3CDTF">2024-06-28T06:52:21Z</dcterms:created>
  <dcterms:modified xsi:type="dcterms:W3CDTF">2024-06-28T06:56:01Z</dcterms:modified>
</cp:coreProperties>
</file>